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>
        <p:scale>
          <a:sx n="83" d="100"/>
          <a:sy n="83" d="100"/>
        </p:scale>
        <p:origin x="700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征治 橋本" userId="09a358cac3b4e199" providerId="LiveId" clId="{75BA4D95-ABB7-468F-AD26-2FE733AB8E64}"/>
    <pc:docChg chg="modSld">
      <pc:chgData name="征治 橋本" userId="09a358cac3b4e199" providerId="LiveId" clId="{75BA4D95-ABB7-468F-AD26-2FE733AB8E64}" dt="2023-10-22T02:56:17.450" v="153" actId="1076"/>
      <pc:docMkLst>
        <pc:docMk/>
      </pc:docMkLst>
      <pc:sldChg chg="modSp mod">
        <pc:chgData name="征治 橋本" userId="09a358cac3b4e199" providerId="LiveId" clId="{75BA4D95-ABB7-468F-AD26-2FE733AB8E64}" dt="2023-10-22T02:49:00.071" v="86" actId="1035"/>
        <pc:sldMkLst>
          <pc:docMk/>
          <pc:sldMk cId="3243158704" sldId="257"/>
        </pc:sldMkLst>
        <pc:spChg chg="mod">
          <ac:chgData name="征治 橋本" userId="09a358cac3b4e199" providerId="LiveId" clId="{75BA4D95-ABB7-468F-AD26-2FE733AB8E64}" dt="2023-10-22T02:49:00.071" v="86" actId="1035"/>
          <ac:spMkLst>
            <pc:docMk/>
            <pc:sldMk cId="3243158704" sldId="257"/>
            <ac:spMk id="18" creationId="{688873A7-C250-C442-937C-7D360C9F808C}"/>
          </ac:spMkLst>
        </pc:spChg>
      </pc:sldChg>
      <pc:sldChg chg="modSp mod">
        <pc:chgData name="征治 橋本" userId="09a358cac3b4e199" providerId="LiveId" clId="{75BA4D95-ABB7-468F-AD26-2FE733AB8E64}" dt="2023-10-22T02:48:53.309" v="67" actId="1035"/>
        <pc:sldMkLst>
          <pc:docMk/>
          <pc:sldMk cId="1297914662" sldId="258"/>
        </pc:sldMkLst>
        <pc:spChg chg="mod">
          <ac:chgData name="征治 橋本" userId="09a358cac3b4e199" providerId="LiveId" clId="{75BA4D95-ABB7-468F-AD26-2FE733AB8E64}" dt="2023-10-22T02:48:53.309" v="67" actId="1035"/>
          <ac:spMkLst>
            <pc:docMk/>
            <pc:sldMk cId="1297914662" sldId="258"/>
            <ac:spMk id="18" creationId="{688873A7-C250-C442-937C-7D360C9F808C}"/>
          </ac:spMkLst>
        </pc:spChg>
      </pc:sldChg>
      <pc:sldChg chg="addSp modSp mod">
        <pc:chgData name="征治 橋本" userId="09a358cac3b4e199" providerId="LiveId" clId="{75BA4D95-ABB7-468F-AD26-2FE733AB8E64}" dt="2023-10-22T02:53:38.961" v="125" actId="1076"/>
        <pc:sldMkLst>
          <pc:docMk/>
          <pc:sldMk cId="2299710068" sldId="259"/>
        </pc:sldMkLst>
        <pc:spChg chg="mod">
          <ac:chgData name="征治 橋本" userId="09a358cac3b4e199" providerId="LiveId" clId="{75BA4D95-ABB7-468F-AD26-2FE733AB8E64}" dt="2023-10-22T02:48:41.588" v="38" actId="1035"/>
          <ac:spMkLst>
            <pc:docMk/>
            <pc:sldMk cId="2299710068" sldId="259"/>
            <ac:spMk id="18" creationId="{688873A7-C250-C442-937C-7D360C9F808C}"/>
          </ac:spMkLst>
        </pc:spChg>
        <pc:picChg chg="add mod">
          <ac:chgData name="征治 橋本" userId="09a358cac3b4e199" providerId="LiveId" clId="{75BA4D95-ABB7-468F-AD26-2FE733AB8E64}" dt="2023-10-22T02:47:49.894" v="6" actId="1076"/>
          <ac:picMkLst>
            <pc:docMk/>
            <pc:sldMk cId="2299710068" sldId="259"/>
            <ac:picMk id="5" creationId="{D035E982-57E3-F798-C512-B8E99524C7A4}"/>
          </ac:picMkLst>
        </pc:picChg>
        <pc:picChg chg="add mod">
          <ac:chgData name="征治 橋本" userId="09a358cac3b4e199" providerId="LiveId" clId="{75BA4D95-ABB7-468F-AD26-2FE733AB8E64}" dt="2023-10-22T02:48:32.382" v="9" actId="1076"/>
          <ac:picMkLst>
            <pc:docMk/>
            <pc:sldMk cId="2299710068" sldId="259"/>
            <ac:picMk id="9" creationId="{568D571C-B207-055D-024C-4E0FF57E42D0}"/>
          </ac:picMkLst>
        </pc:picChg>
        <pc:picChg chg="add mod">
          <ac:chgData name="征治 橋本" userId="09a358cac3b4e199" providerId="LiveId" clId="{75BA4D95-ABB7-468F-AD26-2FE733AB8E64}" dt="2023-10-22T02:49:30.694" v="116" actId="1076"/>
          <ac:picMkLst>
            <pc:docMk/>
            <pc:sldMk cId="2299710068" sldId="259"/>
            <ac:picMk id="13" creationId="{24A557C1-625A-45B8-8CA5-8526D3D1E845}"/>
          </ac:picMkLst>
        </pc:picChg>
        <pc:picChg chg="add mod">
          <ac:chgData name="征治 橋本" userId="09a358cac3b4e199" providerId="LiveId" clId="{75BA4D95-ABB7-468F-AD26-2FE733AB8E64}" dt="2023-10-22T02:49:48.352" v="119" actId="1076"/>
          <ac:picMkLst>
            <pc:docMk/>
            <pc:sldMk cId="2299710068" sldId="259"/>
            <ac:picMk id="25" creationId="{29BFB322-A56E-626D-C71E-1B1B20184A9B}"/>
          </ac:picMkLst>
        </pc:picChg>
        <pc:picChg chg="add mod">
          <ac:chgData name="征治 橋本" userId="09a358cac3b4e199" providerId="LiveId" clId="{75BA4D95-ABB7-468F-AD26-2FE733AB8E64}" dt="2023-10-22T02:53:20.453" v="122" actId="1076"/>
          <ac:picMkLst>
            <pc:docMk/>
            <pc:sldMk cId="2299710068" sldId="259"/>
            <ac:picMk id="27" creationId="{29F3662F-03D9-A980-2CB9-9E230C3C8AF3}"/>
          </ac:picMkLst>
        </pc:picChg>
        <pc:picChg chg="add mod">
          <ac:chgData name="征治 橋本" userId="09a358cac3b4e199" providerId="LiveId" clId="{75BA4D95-ABB7-468F-AD26-2FE733AB8E64}" dt="2023-10-22T02:53:38.961" v="125" actId="1076"/>
          <ac:picMkLst>
            <pc:docMk/>
            <pc:sldMk cId="2299710068" sldId="259"/>
            <ac:picMk id="29" creationId="{B0F37B30-AB19-C8C9-5451-0FC3ED1FFF94}"/>
          </ac:picMkLst>
        </pc:picChg>
      </pc:sldChg>
      <pc:sldChg chg="addSp modSp mod">
        <pc:chgData name="征治 橋本" userId="09a358cac3b4e199" providerId="LiveId" clId="{75BA4D95-ABB7-468F-AD26-2FE733AB8E64}" dt="2023-10-22T02:56:17.450" v="153" actId="1076"/>
        <pc:sldMkLst>
          <pc:docMk/>
          <pc:sldMk cId="375678960" sldId="260"/>
        </pc:sldMkLst>
        <pc:spChg chg="mod">
          <ac:chgData name="征治 橋本" userId="09a358cac3b4e199" providerId="LiveId" clId="{75BA4D95-ABB7-468F-AD26-2FE733AB8E64}" dt="2023-10-22T02:49:08.730" v="113" actId="1035"/>
          <ac:spMkLst>
            <pc:docMk/>
            <pc:sldMk cId="375678960" sldId="260"/>
            <ac:spMk id="18" creationId="{688873A7-C250-C442-937C-7D360C9F808C}"/>
          </ac:spMkLst>
        </pc:spChg>
        <pc:picChg chg="add mod">
          <ac:chgData name="征治 橋本" userId="09a358cac3b4e199" providerId="LiveId" clId="{75BA4D95-ABB7-468F-AD26-2FE733AB8E64}" dt="2023-10-22T02:54:49.716" v="137" actId="1076"/>
          <ac:picMkLst>
            <pc:docMk/>
            <pc:sldMk cId="375678960" sldId="260"/>
            <ac:picMk id="9" creationId="{D0A0C719-CFEC-8435-2E30-A0A5DA8AB309}"/>
          </ac:picMkLst>
        </pc:picChg>
        <pc:picChg chg="add mod">
          <ac:chgData name="征治 橋本" userId="09a358cac3b4e199" providerId="LiveId" clId="{75BA4D95-ABB7-468F-AD26-2FE733AB8E64}" dt="2023-10-22T02:54:43.222" v="135" actId="1076"/>
          <ac:picMkLst>
            <pc:docMk/>
            <pc:sldMk cId="375678960" sldId="260"/>
            <ac:picMk id="13" creationId="{1A8124B6-E408-09FC-F9E0-ACC06C92A32A}"/>
          </ac:picMkLst>
        </pc:picChg>
        <pc:picChg chg="add mod">
          <ac:chgData name="征治 橋本" userId="09a358cac3b4e199" providerId="LiveId" clId="{75BA4D95-ABB7-468F-AD26-2FE733AB8E64}" dt="2023-10-22T02:55:16.157" v="144" actId="1076"/>
          <ac:picMkLst>
            <pc:docMk/>
            <pc:sldMk cId="375678960" sldId="260"/>
            <ac:picMk id="25" creationId="{FE12D794-8CD5-0EAC-93A2-43D8E9AFF8F0}"/>
          </ac:picMkLst>
        </pc:picChg>
        <pc:picChg chg="add mod">
          <ac:chgData name="征治 橋本" userId="09a358cac3b4e199" providerId="LiveId" clId="{75BA4D95-ABB7-468F-AD26-2FE733AB8E64}" dt="2023-10-22T02:55:33.569" v="147" actId="1076"/>
          <ac:picMkLst>
            <pc:docMk/>
            <pc:sldMk cId="375678960" sldId="260"/>
            <ac:picMk id="27" creationId="{204FB3E4-6937-8639-3FB7-F7275E5F8F9C}"/>
          </ac:picMkLst>
        </pc:picChg>
        <pc:picChg chg="add mod">
          <ac:chgData name="征治 橋本" userId="09a358cac3b4e199" providerId="LiveId" clId="{75BA4D95-ABB7-468F-AD26-2FE733AB8E64}" dt="2023-10-22T02:55:58.652" v="150" actId="1076"/>
          <ac:picMkLst>
            <pc:docMk/>
            <pc:sldMk cId="375678960" sldId="260"/>
            <ac:picMk id="29" creationId="{9743B4F9-A0CD-BF8A-6B95-259D81C47C59}"/>
          </ac:picMkLst>
        </pc:picChg>
        <pc:picChg chg="add mod">
          <ac:chgData name="征治 橋本" userId="09a358cac3b4e199" providerId="LiveId" clId="{75BA4D95-ABB7-468F-AD26-2FE733AB8E64}" dt="2023-10-22T02:56:17.450" v="153" actId="1076"/>
          <ac:picMkLst>
            <pc:docMk/>
            <pc:sldMk cId="375678960" sldId="260"/>
            <ac:picMk id="31" creationId="{DB37F739-91D8-2243-A956-0E4DA26D95E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9B14F5-F8F4-BCDB-598B-771CC36455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93F7C7F-F1E9-4DF6-F2AC-831E04F8F1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3ED21C-AA2D-7E08-DCFC-404628626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49B2B9-5B17-CEE6-CE64-59134A579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D88B8F-74E2-3F11-FADF-55EF1838A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044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BCDCE5-9CB1-9B53-3AF9-0021B046E0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86F3919-7ABD-9C27-BFD4-E45C8FF76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BE2BF8-8B9E-86AA-F66F-356D99CA6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958B22-83A7-B966-BD5B-1143F9F86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2C848C-522E-5F32-74A6-E32A2540A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287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050BCD5-3188-DCD3-B804-EA04538C38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34AB719-4AB8-5805-FFF8-FC88DE90E6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50B3D25-5D3A-013F-CDE0-C8E162DDF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F87322-35F1-65CB-F1A2-9912FF8BC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9CB62B-6174-656C-1947-B36FF423E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634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BF2A7D-F1DF-D15C-558B-7EF09BF82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6CA0926-E62C-7B0F-07DA-3DBF217067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5F83F2-2D88-CE8B-748B-EA52C4A4EE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F1C863-D919-991B-DEC4-D62A1D0CE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9701C5-BEE5-7733-DA98-13BA4E6E6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314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E9FF2C-97F6-922D-A010-9D47B34955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99598B6-2A56-949A-48C9-3A9CE1FB8E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80E8EA-D2C9-D644-6104-FAFC7FAB4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9FFFF9-65F2-75A8-0FDB-CDD3D4F4C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0D39BB-F589-595A-A999-584C1DBC9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924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D5C9C9-527D-D3E6-DF7A-893B8FBF81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60D7C3-E9EA-B16A-F6BB-AE90F82E16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D5CBD42-C08B-E14B-E5FD-E0367291E7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83A00B1-7FBC-DAE8-6C1B-0667E52D3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7EBDC8C-9788-2A17-A8FE-FDC3DE0F7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D983063-5719-8434-574C-6ABA6F82A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675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0987A5-5A02-2DA8-8602-CBFEA99EF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4F73CD4-81D4-3B12-37F6-61A4B43397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27ABE08-1582-25B4-33BC-6C0659C9D0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898DCED-6C39-BA01-946F-4183B72693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BBAEDB6-40BF-E582-8BF4-24D33D571E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F5F2CD0-037C-1F4E-EF8F-82F6C1C04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FF3EC30-6A27-4B8D-DA69-77652D5A3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27BC2B0-C2ED-891A-CFED-0BA1199B8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58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750A16-BCC8-846D-189F-9BC897ED6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CF38BEB-A612-86DC-2CC0-EFAD296CE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546CE94-7505-B273-0E51-A32764B88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A7C34FA-71C4-0AEB-E26B-E7CA2F05E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57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EB7CBD3-2575-9934-2985-F074D5F9B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AB1F79C-634B-4148-087B-30FEDAC38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1C8A81B-EB01-11B8-FDCB-5CAEFBC3C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770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4242C9-8303-F2C9-AD8A-DBC03DA88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D1BC1FB-3FFD-CAD1-65EB-B352B80C21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0A21D5B-CB87-4B22-F795-4CC687C1F1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B3C980-C7F6-31B4-8835-6F4CAAE5B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1BA6099-5401-82CB-2349-D0CDC61BE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47811B8-8902-4980-7313-3232B46D2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432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2B7D1D-F657-43AD-CC96-785D8FE7C6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D0DD598-37A2-5AD2-5678-2DF76DDA23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68F2D21-5727-81FE-94FA-B4E9212A8A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2E893B1-3B11-1C57-E1AC-C648E51EF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CE114A-42A7-4B39-793E-13EAB21A3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DDD1D8-5501-678C-4F55-EA47F6693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8116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603A669-97D1-EB6F-B3A8-127673C3B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0C9D58F-A631-FB71-188E-1778AC658D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24A538-7128-2BDD-E49F-46C6A2A9B8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15F04-7E28-4606-86B3-A864FD9DDE51}" type="datetimeFigureOut">
              <a:rPr kumimoji="1" lang="ja-JP" altLang="en-US" smtClean="0"/>
              <a:t>2023/10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F6DEE9-2E1D-93CE-4039-0815BEE75C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3664AB-2BDD-BFAE-6D1D-B18EF8E61C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83066-466F-451F-9FFA-2AFAA8AAB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5039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6995B9-9C36-27EB-CB9D-9FA42A044974}"/>
              </a:ext>
            </a:extLst>
          </p:cNvPr>
          <p:cNvSpPr txBox="1"/>
          <p:nvPr/>
        </p:nvSpPr>
        <p:spPr>
          <a:xfrm>
            <a:off x="275208" y="195309"/>
            <a:ext cx="1589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1</a:t>
            </a:r>
            <a:endParaRPr kumimoji="1" lang="ja-JP" altLang="en-US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30BA26E-3B8B-2944-3670-F8238AFC90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2160" y="1084667"/>
            <a:ext cx="3474058" cy="259556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7687BB2F-9FF8-5176-FCD1-F1DEEFC890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5627" y="4059569"/>
            <a:ext cx="3616100" cy="2701684"/>
          </a:xfrm>
          <a:prstGeom prst="rect">
            <a:avLst/>
          </a:prstGeom>
        </p:spPr>
      </p:pic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15C8A2BA-F408-5516-AA4E-140518A4E2C1}"/>
              </a:ext>
            </a:extLst>
          </p:cNvPr>
          <p:cNvCxnSpPr/>
          <p:nvPr/>
        </p:nvCxnSpPr>
        <p:spPr>
          <a:xfrm>
            <a:off x="133165" y="3893768"/>
            <a:ext cx="11656381" cy="0"/>
          </a:xfrm>
          <a:prstGeom prst="line">
            <a:avLst/>
          </a:prstGeom>
          <a:ln w="571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図 9">
            <a:extLst>
              <a:ext uri="{FF2B5EF4-FFF2-40B4-BE49-F238E27FC236}">
                <a16:creationId xmlns:a16="http://schemas.microsoft.com/office/drawing/2014/main" id="{D4F1EB34-D6E2-17E7-41B4-F48DD58988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8534" y="1058349"/>
            <a:ext cx="3556814" cy="265739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9B5CC55C-FDE9-740A-BA53-746A612B0A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8134" y="4092923"/>
            <a:ext cx="3550580" cy="265273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E302930-9B91-77C9-B1CB-93DD93E2167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82912" y="1058348"/>
            <a:ext cx="3649620" cy="2726727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0A025B99-964B-3A47-76EB-09853D7DC18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45309" y="4014398"/>
            <a:ext cx="3550580" cy="2652732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47721D-E94F-7CF0-42A7-AF92A27E683D}"/>
              </a:ext>
            </a:extLst>
          </p:cNvPr>
          <p:cNvSpPr txBox="1"/>
          <p:nvPr/>
        </p:nvSpPr>
        <p:spPr>
          <a:xfrm>
            <a:off x="79102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chemeClr val="accent1"/>
                </a:solidFill>
              </a:rPr>
              <a:t>p</a:t>
            </a:r>
            <a:r>
              <a:rPr lang="en-US" altLang="ja-JP" b="1" dirty="0">
                <a:solidFill>
                  <a:schemeClr val="accent1"/>
                </a:solidFill>
              </a:rPr>
              <a:t>-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88873A7-C250-C442-937C-7D360C9F808C}"/>
              </a:ext>
            </a:extLst>
          </p:cNvPr>
          <p:cNvSpPr txBox="1"/>
          <p:nvPr/>
        </p:nvSpPr>
        <p:spPr>
          <a:xfrm>
            <a:off x="-46216" y="4002978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chemeClr val="accent1"/>
                </a:solidFill>
              </a:rPr>
              <a:t>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F33B33E7-732D-3043-A78F-1761C5FA3873}"/>
              </a:ext>
            </a:extLst>
          </p:cNvPr>
          <p:cNvSpPr/>
          <p:nvPr/>
        </p:nvSpPr>
        <p:spPr>
          <a:xfrm>
            <a:off x="825627" y="96403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36B95F8E-4CBE-6332-A821-707B9596CDD8}"/>
              </a:ext>
            </a:extLst>
          </p:cNvPr>
          <p:cNvSpPr/>
          <p:nvPr/>
        </p:nvSpPr>
        <p:spPr>
          <a:xfrm>
            <a:off x="4555739" y="965512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9F86134-1BCF-8998-E2A8-178496FCEA51}"/>
              </a:ext>
            </a:extLst>
          </p:cNvPr>
          <p:cNvSpPr/>
          <p:nvPr/>
        </p:nvSpPr>
        <p:spPr>
          <a:xfrm>
            <a:off x="8364269" y="93887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FA23A82-B2C2-C0BC-2A2F-1512CABCC45D}"/>
              </a:ext>
            </a:extLst>
          </p:cNvPr>
          <p:cNvSpPr txBox="1"/>
          <p:nvPr/>
        </p:nvSpPr>
        <p:spPr>
          <a:xfrm>
            <a:off x="2313789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b="1" dirty="0">
                <a:solidFill>
                  <a:srgbClr val="FF0000"/>
                </a:solidFill>
              </a:rPr>
              <a:t>①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C301418-3D8A-9202-8B98-A6DD2095E4A1}"/>
              </a:ext>
            </a:extLst>
          </p:cNvPr>
          <p:cNvSpPr txBox="1"/>
          <p:nvPr/>
        </p:nvSpPr>
        <p:spPr>
          <a:xfrm>
            <a:off x="6247088" y="589440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②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95749CA-ADFC-0802-A42F-2F0EEAC1C39F}"/>
              </a:ext>
            </a:extLst>
          </p:cNvPr>
          <p:cNvSpPr txBox="1"/>
          <p:nvPr/>
        </p:nvSpPr>
        <p:spPr>
          <a:xfrm>
            <a:off x="10017767" y="561544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③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3158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6995B9-9C36-27EB-CB9D-9FA42A044974}"/>
              </a:ext>
            </a:extLst>
          </p:cNvPr>
          <p:cNvSpPr txBox="1"/>
          <p:nvPr/>
        </p:nvSpPr>
        <p:spPr>
          <a:xfrm>
            <a:off x="275208" y="195309"/>
            <a:ext cx="1589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2b</a:t>
            </a: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15C8A2BA-F408-5516-AA4E-140518A4E2C1}"/>
              </a:ext>
            </a:extLst>
          </p:cNvPr>
          <p:cNvCxnSpPr/>
          <p:nvPr/>
        </p:nvCxnSpPr>
        <p:spPr>
          <a:xfrm>
            <a:off x="133165" y="3893768"/>
            <a:ext cx="11656381" cy="0"/>
          </a:xfrm>
          <a:prstGeom prst="line">
            <a:avLst/>
          </a:prstGeom>
          <a:ln w="571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47721D-E94F-7CF0-42A7-AF92A27E683D}"/>
              </a:ext>
            </a:extLst>
          </p:cNvPr>
          <p:cNvSpPr txBox="1"/>
          <p:nvPr/>
        </p:nvSpPr>
        <p:spPr>
          <a:xfrm>
            <a:off x="79102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chemeClr val="accent1"/>
                </a:solidFill>
              </a:rPr>
              <a:t>p</a:t>
            </a:r>
            <a:r>
              <a:rPr lang="en-US" altLang="ja-JP" b="1" dirty="0">
                <a:solidFill>
                  <a:schemeClr val="accent1"/>
                </a:solidFill>
              </a:rPr>
              <a:t>-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88873A7-C250-C442-937C-7D360C9F808C}"/>
              </a:ext>
            </a:extLst>
          </p:cNvPr>
          <p:cNvSpPr txBox="1"/>
          <p:nvPr/>
        </p:nvSpPr>
        <p:spPr>
          <a:xfrm>
            <a:off x="-46216" y="3979926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chemeClr val="accent1"/>
                </a:solidFill>
              </a:rPr>
              <a:t>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F33B33E7-732D-3043-A78F-1761C5FA3873}"/>
              </a:ext>
            </a:extLst>
          </p:cNvPr>
          <p:cNvSpPr/>
          <p:nvPr/>
        </p:nvSpPr>
        <p:spPr>
          <a:xfrm>
            <a:off x="825627" y="96403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36B95F8E-4CBE-6332-A821-707B9596CDD8}"/>
              </a:ext>
            </a:extLst>
          </p:cNvPr>
          <p:cNvSpPr/>
          <p:nvPr/>
        </p:nvSpPr>
        <p:spPr>
          <a:xfrm>
            <a:off x="4555739" y="965512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9F86134-1BCF-8998-E2A8-178496FCEA51}"/>
              </a:ext>
            </a:extLst>
          </p:cNvPr>
          <p:cNvSpPr/>
          <p:nvPr/>
        </p:nvSpPr>
        <p:spPr>
          <a:xfrm>
            <a:off x="8364269" y="93887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FA23A82-B2C2-C0BC-2A2F-1512CABCC45D}"/>
              </a:ext>
            </a:extLst>
          </p:cNvPr>
          <p:cNvSpPr txBox="1"/>
          <p:nvPr/>
        </p:nvSpPr>
        <p:spPr>
          <a:xfrm>
            <a:off x="2313789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b="1" dirty="0">
                <a:solidFill>
                  <a:srgbClr val="FF0000"/>
                </a:solidFill>
              </a:rPr>
              <a:t>①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C301418-3D8A-9202-8B98-A6DD2095E4A1}"/>
              </a:ext>
            </a:extLst>
          </p:cNvPr>
          <p:cNvSpPr txBox="1"/>
          <p:nvPr/>
        </p:nvSpPr>
        <p:spPr>
          <a:xfrm>
            <a:off x="6247088" y="589440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②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95749CA-ADFC-0802-A42F-2F0EEAC1C39F}"/>
              </a:ext>
            </a:extLst>
          </p:cNvPr>
          <p:cNvSpPr txBox="1"/>
          <p:nvPr/>
        </p:nvSpPr>
        <p:spPr>
          <a:xfrm>
            <a:off x="10017767" y="561544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③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82C15D53-E96C-0288-614C-7FD06FB220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9759" y="1302499"/>
            <a:ext cx="2967412" cy="221703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464D4E8C-4861-94FD-710D-92F579B58F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3632" y="1244986"/>
            <a:ext cx="3201335" cy="2391802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DA99BE08-FF11-6D73-FA94-00B67E500C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41778" y="1134740"/>
            <a:ext cx="3416488" cy="2552549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CEEB8FB6-CA36-8454-04F5-F029444753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4689" y="4004362"/>
            <a:ext cx="3430627" cy="2563112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1F186B07-48CD-1140-0E73-C2BDD5115DE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77742" y="4075664"/>
            <a:ext cx="3239755" cy="2420507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E29149B3-1A9A-71AA-6390-452EC8868C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95351" y="4289061"/>
            <a:ext cx="2909342" cy="21736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7914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6995B9-9C36-27EB-CB9D-9FA42A044974}"/>
              </a:ext>
            </a:extLst>
          </p:cNvPr>
          <p:cNvSpPr txBox="1"/>
          <p:nvPr/>
        </p:nvSpPr>
        <p:spPr>
          <a:xfrm>
            <a:off x="275208" y="195309"/>
            <a:ext cx="1589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2e</a:t>
            </a:r>
            <a:endParaRPr kumimoji="1" lang="ja-JP" altLang="en-US" dirty="0"/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15C8A2BA-F408-5516-AA4E-140518A4E2C1}"/>
              </a:ext>
            </a:extLst>
          </p:cNvPr>
          <p:cNvCxnSpPr/>
          <p:nvPr/>
        </p:nvCxnSpPr>
        <p:spPr>
          <a:xfrm>
            <a:off x="133165" y="3893768"/>
            <a:ext cx="11656381" cy="0"/>
          </a:xfrm>
          <a:prstGeom prst="line">
            <a:avLst/>
          </a:prstGeom>
          <a:ln w="571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47721D-E94F-7CF0-42A7-AF92A27E683D}"/>
              </a:ext>
            </a:extLst>
          </p:cNvPr>
          <p:cNvSpPr txBox="1"/>
          <p:nvPr/>
        </p:nvSpPr>
        <p:spPr>
          <a:xfrm>
            <a:off x="79102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chemeClr val="accent1"/>
                </a:solidFill>
              </a:rPr>
              <a:t>p</a:t>
            </a:r>
            <a:r>
              <a:rPr lang="en-US" altLang="ja-JP" b="1" dirty="0">
                <a:solidFill>
                  <a:schemeClr val="accent1"/>
                </a:solidFill>
              </a:rPr>
              <a:t>-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88873A7-C250-C442-937C-7D360C9F808C}"/>
              </a:ext>
            </a:extLst>
          </p:cNvPr>
          <p:cNvSpPr txBox="1"/>
          <p:nvPr/>
        </p:nvSpPr>
        <p:spPr>
          <a:xfrm>
            <a:off x="-38532" y="397224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chemeClr val="accent1"/>
                </a:solidFill>
              </a:rPr>
              <a:t>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F33B33E7-732D-3043-A78F-1761C5FA3873}"/>
              </a:ext>
            </a:extLst>
          </p:cNvPr>
          <p:cNvSpPr/>
          <p:nvPr/>
        </p:nvSpPr>
        <p:spPr>
          <a:xfrm>
            <a:off x="825627" y="96403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36B95F8E-4CBE-6332-A821-707B9596CDD8}"/>
              </a:ext>
            </a:extLst>
          </p:cNvPr>
          <p:cNvSpPr/>
          <p:nvPr/>
        </p:nvSpPr>
        <p:spPr>
          <a:xfrm>
            <a:off x="4555739" y="965512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9F86134-1BCF-8998-E2A8-178496FCEA51}"/>
              </a:ext>
            </a:extLst>
          </p:cNvPr>
          <p:cNvSpPr/>
          <p:nvPr/>
        </p:nvSpPr>
        <p:spPr>
          <a:xfrm>
            <a:off x="8364269" y="93887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FA23A82-B2C2-C0BC-2A2F-1512CABCC45D}"/>
              </a:ext>
            </a:extLst>
          </p:cNvPr>
          <p:cNvSpPr txBox="1"/>
          <p:nvPr/>
        </p:nvSpPr>
        <p:spPr>
          <a:xfrm>
            <a:off x="2313789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b="1" dirty="0">
                <a:solidFill>
                  <a:srgbClr val="FF0000"/>
                </a:solidFill>
              </a:rPr>
              <a:t>①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C301418-3D8A-9202-8B98-A6DD2095E4A1}"/>
              </a:ext>
            </a:extLst>
          </p:cNvPr>
          <p:cNvSpPr txBox="1"/>
          <p:nvPr/>
        </p:nvSpPr>
        <p:spPr>
          <a:xfrm>
            <a:off x="6247088" y="589440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②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95749CA-ADFC-0802-A42F-2F0EEAC1C39F}"/>
              </a:ext>
            </a:extLst>
          </p:cNvPr>
          <p:cNvSpPr txBox="1"/>
          <p:nvPr/>
        </p:nvSpPr>
        <p:spPr>
          <a:xfrm>
            <a:off x="10017767" y="561544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③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035E982-57E3-F798-C512-B8E99524C7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1879" y="1125863"/>
            <a:ext cx="3383721" cy="252806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68D571C-B207-055D-024C-4E0FF57E42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9210" y="4213479"/>
            <a:ext cx="3278176" cy="244921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24A557C1-625A-45B8-8CA5-8526D3D1E8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84902" y="1198609"/>
            <a:ext cx="3385752" cy="2529585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29BFB322-A56E-626D-C71E-1B1B20184A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6688" y="4136276"/>
            <a:ext cx="3408804" cy="2546808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29F3662F-03D9-A980-2CB9-9E230C3C8A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09956" y="1222700"/>
            <a:ext cx="3124495" cy="2334393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B0F37B30-AB19-C8C9-5451-0FC3ED1FFF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48099" y="4200076"/>
            <a:ext cx="3147547" cy="23516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9710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6995B9-9C36-27EB-CB9D-9FA42A044974}"/>
              </a:ext>
            </a:extLst>
          </p:cNvPr>
          <p:cNvSpPr txBox="1"/>
          <p:nvPr/>
        </p:nvSpPr>
        <p:spPr>
          <a:xfrm>
            <a:off x="275208" y="195309"/>
            <a:ext cx="1589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ure 3</a:t>
            </a:r>
            <a:endParaRPr kumimoji="1" lang="ja-JP" altLang="en-US" dirty="0"/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15C8A2BA-F408-5516-AA4E-140518A4E2C1}"/>
              </a:ext>
            </a:extLst>
          </p:cNvPr>
          <p:cNvCxnSpPr/>
          <p:nvPr/>
        </p:nvCxnSpPr>
        <p:spPr>
          <a:xfrm>
            <a:off x="133165" y="3893768"/>
            <a:ext cx="11656381" cy="0"/>
          </a:xfrm>
          <a:prstGeom prst="line">
            <a:avLst/>
          </a:prstGeom>
          <a:ln w="571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F47721D-E94F-7CF0-42A7-AF92A27E683D}"/>
              </a:ext>
            </a:extLst>
          </p:cNvPr>
          <p:cNvSpPr txBox="1"/>
          <p:nvPr/>
        </p:nvSpPr>
        <p:spPr>
          <a:xfrm>
            <a:off x="79102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chemeClr val="accent1"/>
                </a:solidFill>
              </a:rPr>
              <a:t>p</a:t>
            </a:r>
            <a:r>
              <a:rPr lang="en-US" altLang="ja-JP" b="1" dirty="0">
                <a:solidFill>
                  <a:schemeClr val="accent1"/>
                </a:solidFill>
              </a:rPr>
              <a:t>-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88873A7-C250-C442-937C-7D360C9F808C}"/>
              </a:ext>
            </a:extLst>
          </p:cNvPr>
          <p:cNvSpPr txBox="1"/>
          <p:nvPr/>
        </p:nvSpPr>
        <p:spPr>
          <a:xfrm>
            <a:off x="-38532" y="3987610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solidFill>
                  <a:schemeClr val="accent1"/>
                </a:solidFill>
              </a:rPr>
              <a:t>STAT3</a:t>
            </a:r>
            <a:endParaRPr kumimoji="1" lang="ja-JP" altLang="en-US" b="1" dirty="0">
              <a:solidFill>
                <a:schemeClr val="accent1"/>
              </a:solidFill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F33B33E7-732D-3043-A78F-1761C5FA3873}"/>
              </a:ext>
            </a:extLst>
          </p:cNvPr>
          <p:cNvSpPr/>
          <p:nvPr/>
        </p:nvSpPr>
        <p:spPr>
          <a:xfrm>
            <a:off x="825627" y="96403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36B95F8E-4CBE-6332-A821-707B9596CDD8}"/>
              </a:ext>
            </a:extLst>
          </p:cNvPr>
          <p:cNvSpPr/>
          <p:nvPr/>
        </p:nvSpPr>
        <p:spPr>
          <a:xfrm>
            <a:off x="4555739" y="965512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59F86134-1BCF-8998-E2A8-178496FCEA51}"/>
              </a:ext>
            </a:extLst>
          </p:cNvPr>
          <p:cNvSpPr/>
          <p:nvPr/>
        </p:nvSpPr>
        <p:spPr>
          <a:xfrm>
            <a:off x="8364269" y="938878"/>
            <a:ext cx="3605343" cy="5893962"/>
          </a:xfrm>
          <a:prstGeom prst="rect">
            <a:avLst/>
          </a:prstGeom>
          <a:noFill/>
          <a:ln w="571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FA23A82-B2C2-C0BC-2A2F-1512CABCC45D}"/>
              </a:ext>
            </a:extLst>
          </p:cNvPr>
          <p:cNvSpPr txBox="1"/>
          <p:nvPr/>
        </p:nvSpPr>
        <p:spPr>
          <a:xfrm>
            <a:off x="2313789" y="577412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b="1" dirty="0">
                <a:solidFill>
                  <a:srgbClr val="FF0000"/>
                </a:solidFill>
              </a:rPr>
              <a:t>①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C301418-3D8A-9202-8B98-A6DD2095E4A1}"/>
              </a:ext>
            </a:extLst>
          </p:cNvPr>
          <p:cNvSpPr txBox="1"/>
          <p:nvPr/>
        </p:nvSpPr>
        <p:spPr>
          <a:xfrm>
            <a:off x="6247088" y="589440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②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95749CA-ADFC-0802-A42F-2F0EEAC1C39F}"/>
              </a:ext>
            </a:extLst>
          </p:cNvPr>
          <p:cNvSpPr txBox="1"/>
          <p:nvPr/>
        </p:nvSpPr>
        <p:spPr>
          <a:xfrm>
            <a:off x="10017767" y="561544"/>
            <a:ext cx="1677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b="1" dirty="0">
                <a:solidFill>
                  <a:srgbClr val="FF0000"/>
                </a:solidFill>
              </a:rPr>
              <a:t>③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D0A0C719-CFEC-8435-2E30-A0A5DA8AB3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3655" y="1183168"/>
            <a:ext cx="3242207" cy="2422339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A8124B6-E408-09FC-F9E0-ACC06C92A3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3062" y="4025952"/>
            <a:ext cx="3469777" cy="2592362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FE12D794-8CD5-0EAC-93A2-43D8E9AFF8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5288" y="1136832"/>
            <a:ext cx="3366244" cy="251501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204FB3E4-6937-8639-3FB7-F7275E5F8F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30072" y="1115526"/>
            <a:ext cx="3439540" cy="2569771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9743B4F9-A0CD-BF8A-6B95-259D81C47C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17608" y="4073775"/>
            <a:ext cx="3485645" cy="2604218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DB37F739-91D8-2243-A956-0E4DA26D95E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87702" y="4172276"/>
            <a:ext cx="3324280" cy="2483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678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28</Words>
  <Application>Microsoft Office PowerPoint</Application>
  <PresentationFormat>ワイド画面</PresentationFormat>
  <Paragraphs>2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征治 橋本</dc:creator>
  <cp:lastModifiedBy>征治 橋本</cp:lastModifiedBy>
  <cp:revision>1</cp:revision>
  <dcterms:created xsi:type="dcterms:W3CDTF">2023-10-22T00:35:54Z</dcterms:created>
  <dcterms:modified xsi:type="dcterms:W3CDTF">2023-10-22T02:56:24Z</dcterms:modified>
</cp:coreProperties>
</file>